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1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3D06D4C-EDA7-475A-AB03-0DE12463C63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EA9D9807-F45D-4CD9-9B22-5A9DA3035BE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2E44CAB-36EA-48FE-BA00-4D8AB1CE86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CE8EE-CC1C-43E8-8E67-A3BFF427310E}" type="datetimeFigureOut">
              <a:rPr lang="it-IT" smtClean="0"/>
              <a:t>31/07/20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DCADE49-0CD3-47FF-A537-72D0777E1C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6416AA7-D4D2-4196-8A03-0FE8135C07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6D32A-D71B-4497-B15D-CD20E01DA68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407850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03A31B8-9359-46DC-A15B-21C68A1C5E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B823B27-D4E6-453C-A54D-0D5546B3B8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8A1D17C-3A5F-45B2-A214-EA9787F244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CE8EE-CC1C-43E8-8E67-A3BFF427310E}" type="datetimeFigureOut">
              <a:rPr lang="it-IT" smtClean="0"/>
              <a:t>31/07/20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4E76AAC-4601-4032-B8B9-E2CF14284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27B930E-60E6-4CCA-AA36-F52311C690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6D32A-D71B-4497-B15D-CD20E01DA68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747529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3B4110D4-D111-4088-8E0B-47BBAD8F9EB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9E0F1088-B975-482A-8BBB-83DBA38D13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852F57D-856B-4DD1-B303-E942765FF6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CE8EE-CC1C-43E8-8E67-A3BFF427310E}" type="datetimeFigureOut">
              <a:rPr lang="it-IT" smtClean="0"/>
              <a:t>31/07/20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594D183-F4BD-4947-90AA-A754EE9457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3CAC3A0-11DB-4834-9C0C-7177FBE890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6D32A-D71B-4497-B15D-CD20E01DA68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305215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F6E85D0-A4F3-4A14-BCD2-5FA4D6E7D2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413F86DE-6C25-4E03-86CF-344F488C4D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853BB9D-98BC-45F1-9776-C370B6CEA1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CE8EE-CC1C-43E8-8E67-A3BFF427310E}" type="datetimeFigureOut">
              <a:rPr lang="it-IT" smtClean="0"/>
              <a:t>31/07/20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725C339-2337-4358-AC36-80DB37E3A3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0BAA2F1-688C-4485-AEDD-BA7E9EA2E0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6D32A-D71B-4497-B15D-CD20E01DA68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124183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5B9A30C-B50F-4FB9-A7C8-D757149773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7835C2F-5554-447D-AD4F-5EB1EF9CDD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14515E1-DE8B-4CFA-AA47-46C2A280C9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CE8EE-CC1C-43E8-8E67-A3BFF427310E}" type="datetimeFigureOut">
              <a:rPr lang="it-IT" smtClean="0"/>
              <a:t>31/07/20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02D64C1-35CD-47F0-BC2E-5506514DCC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72260A7-C987-4B54-99D9-5B8B358AAC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6D32A-D71B-4497-B15D-CD20E01DA68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06792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E3F0798-75C6-474A-93FB-682E5A97B8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44C8E7D-F670-4267-85C5-F352AC408F1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706615C2-3146-42B6-B6DD-57A5EEF949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CD31E61-5DC8-45BB-B070-66301EF4A7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CE8EE-CC1C-43E8-8E67-A3BFF427310E}" type="datetimeFigureOut">
              <a:rPr lang="it-IT" smtClean="0"/>
              <a:t>31/07/2019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408EBE6-DB16-4DDE-AF11-F12BAAF028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9D42AD78-97D2-409D-A502-0107679922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6D32A-D71B-4497-B15D-CD20E01DA68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336326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0A4A1B9-6264-4371-8A4E-0EE3A0F8FA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570ECC2-3D1D-47C0-92F8-883E9846EC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9A4209C3-A9C1-48D8-A563-749EF2E125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9FC2494C-9CFF-4556-BCEE-4B0B5FADF61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66C4AB8D-093A-4A6F-ADCC-54E8ABEDB87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7E39C2CB-9D9A-44D9-A112-A7E644DF7A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CE8EE-CC1C-43E8-8E67-A3BFF427310E}" type="datetimeFigureOut">
              <a:rPr lang="it-IT" smtClean="0"/>
              <a:t>31/07/2019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A9E0EBB7-DFB0-4AFF-A15F-6F676636C5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930B7168-D5B8-4A33-B1F2-016A4AAEE5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6D32A-D71B-4497-B15D-CD20E01DA68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965614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3AC870E-EF71-4E27-A966-563D41C6D1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09F8EC2E-45A9-4EA7-B4B8-64F47DD762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CE8EE-CC1C-43E8-8E67-A3BFF427310E}" type="datetimeFigureOut">
              <a:rPr lang="it-IT" smtClean="0"/>
              <a:t>31/07/2019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45AD695E-15BD-4933-8163-67A166CCD7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B7CA4CF3-1F4B-469F-8493-7BE2EAF4EC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6D32A-D71B-4497-B15D-CD20E01DA68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525530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335F3FDB-38DC-48A4-88F7-56E5A8D955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CE8EE-CC1C-43E8-8E67-A3BFF427310E}" type="datetimeFigureOut">
              <a:rPr lang="it-IT" smtClean="0"/>
              <a:t>31/07/2019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4CF16CE1-4D74-4506-ABB4-0639DA25BE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4E76E963-60F4-4073-A9A7-030A1A63C4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6D32A-D71B-4497-B15D-CD20E01DA68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96631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31903BC-1572-4B90-AE17-A4A96AB7E5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A5B8B8C-2458-4593-948D-45D0603C99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AD32EC50-1489-45F4-9891-590450B535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C908E70-21E1-473C-9C55-98686BABAC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CE8EE-CC1C-43E8-8E67-A3BFF427310E}" type="datetimeFigureOut">
              <a:rPr lang="it-IT" smtClean="0"/>
              <a:t>31/07/2019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971CB3C-B0BC-413D-940C-F605FD1FEB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55AF7FB-4138-4251-93A7-B2F883DCAC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6D32A-D71B-4497-B15D-CD20E01DA68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833390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CFEB80E-0F97-497A-99F5-D56430FDB8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684E94C8-0ABB-48EB-91B1-0A149B07E36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2F0154C-709D-4261-98A5-739B538784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711C4A7-E8B9-45B0-896A-908743298F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CE8EE-CC1C-43E8-8E67-A3BFF427310E}" type="datetimeFigureOut">
              <a:rPr lang="it-IT" smtClean="0"/>
              <a:t>31/07/2019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3C32A27-1771-4791-AFD1-1E393514B3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18E827F-EE69-4BFA-8840-C549978B67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6D32A-D71B-4497-B15D-CD20E01DA68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7409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FCB6F9F2-64B3-4729-BFFE-DAEA2E2F31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DBE0454-5D49-45EC-A0B5-A7213DA765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83FAA7A-8060-480E-9A80-958354F5CFA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2CE8EE-CC1C-43E8-8E67-A3BFF427310E}" type="datetimeFigureOut">
              <a:rPr lang="it-IT" smtClean="0"/>
              <a:t>31/07/20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21878BF-30FD-4DD2-A406-2D0AF04F818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BA88A14-B59C-485B-93E0-4B1969AC942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B6D32A-D71B-4497-B15D-CD20E01DA68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071941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5C52C6D5-D3DF-415C-9A2E-DD8FD6EA80B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33825" y="947887"/>
            <a:ext cx="4076700" cy="4678045"/>
          </a:xfrm>
          <a:prstGeom prst="rect">
            <a:avLst/>
          </a:prstGeom>
        </p:spPr>
      </p:pic>
      <p:sp>
        <p:nvSpPr>
          <p:cNvPr id="3" name="Rettangolo 2"/>
          <p:cNvSpPr/>
          <p:nvPr/>
        </p:nvSpPr>
        <p:spPr>
          <a:xfrm>
            <a:off x="336430" y="5580214"/>
            <a:ext cx="11524891" cy="6850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GB" b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b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5.</a:t>
            </a:r>
            <a:r>
              <a:rPr lang="en-GB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eighbour-joining </a:t>
            </a:r>
            <a:r>
              <a:rPr lang="en-GB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ndrogram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k-means clusters, based on the </a:t>
            </a:r>
            <a:r>
              <a:rPr lang="en-GB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ei’s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enetic distance. Numbers on nodes indicate bootstrap support values, based on 100 replications.</a:t>
            </a:r>
            <a:endParaRPr lang="en-GB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076959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hiara Delvento</dc:creator>
  <cp:lastModifiedBy>Utente</cp:lastModifiedBy>
  <cp:revision>3</cp:revision>
  <dcterms:created xsi:type="dcterms:W3CDTF">2019-07-10T16:32:45Z</dcterms:created>
  <dcterms:modified xsi:type="dcterms:W3CDTF">2019-07-31T07:42:20Z</dcterms:modified>
</cp:coreProperties>
</file>